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283" autoAdjust="0"/>
  </p:normalViewPr>
  <p:slideViewPr>
    <p:cSldViewPr>
      <p:cViewPr varScale="1">
        <p:scale>
          <a:sx n="115" d="100"/>
          <a:sy n="115" d="100"/>
        </p:scale>
        <p:origin x="-936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icnas1.cc.ic.ac.uk\gscad\ITN%23\cat%20pilot\ITN824AD%20-%20Cat%20Pilot%20Study%20-%20Clinical%20Data%20TNSS%20PNIF%20Overall%20VAS%20PEFR%20with%20stats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gscad\AppData\Local\Temp\Temp1_Cat%20Pilot%20Study%20(ITN824AD).zip\ITN824AD%20-%20Cat%20Pilot%20Study%20-%20PNIF%20&#212;&#234;&#229;PNIF%20PEFR%20-%20with%20sta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400" b="0" dirty="0" smtClean="0"/>
              <a:t>Peak expiratory flow rate: dose-response</a:t>
            </a:r>
            <a:endParaRPr lang="en-GB" sz="1400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0282785846531868"/>
          <c:y val="0.11043700812972658"/>
          <c:w val="0.87316777710478499"/>
          <c:h val="0.66685573391891295"/>
        </c:manualLayout>
      </c:layout>
      <c:lineChart>
        <c:grouping val="standard"/>
        <c:varyColors val="0"/>
        <c:ser>
          <c:idx val="0"/>
          <c:order val="0"/>
          <c:tx>
            <c:strRef>
              <c:f>'PEFR stats'!$C$1</c:f>
              <c:strCache>
                <c:ptCount val="1"/>
                <c:pt idx="0">
                  <c:v>diluent challenge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PEFR stats'!$D$25:$D$29</c:f>
                <c:numCache>
                  <c:formatCode>General</c:formatCode>
                  <c:ptCount val="5"/>
                  <c:pt idx="0">
                    <c:v>21.972414782816173</c:v>
                  </c:pt>
                  <c:pt idx="1">
                    <c:v>22.718451518462629</c:v>
                  </c:pt>
                  <c:pt idx="2">
                    <c:v>22.309002609139423</c:v>
                  </c:pt>
                  <c:pt idx="3">
                    <c:v>21.925964572571772</c:v>
                  </c:pt>
                  <c:pt idx="4">
                    <c:v>20.822203860107471</c:v>
                  </c:pt>
                </c:numCache>
              </c:numRef>
            </c:plus>
            <c:minus>
              <c:numRef>
                <c:f>'PEFR stats'!$D$25:$D$29</c:f>
                <c:numCache>
                  <c:formatCode>General</c:formatCode>
                  <c:ptCount val="5"/>
                  <c:pt idx="0">
                    <c:v>21.972414782816173</c:v>
                  </c:pt>
                  <c:pt idx="1">
                    <c:v>22.718451518462629</c:v>
                  </c:pt>
                  <c:pt idx="2">
                    <c:v>22.309002609139423</c:v>
                  </c:pt>
                  <c:pt idx="3">
                    <c:v>21.925964572571772</c:v>
                  </c:pt>
                  <c:pt idx="4">
                    <c:v>20.822203860107471</c:v>
                  </c:pt>
                </c:numCache>
              </c:numRef>
            </c:minus>
          </c:errBars>
          <c:cat>
            <c:strRef>
              <c:f>'PEFR stats'!$F$25:$F$30</c:f>
              <c:strCache>
                <c:ptCount val="6"/>
                <c:pt idx="0">
                  <c:v>post-lavage</c:v>
                </c:pt>
                <c:pt idx="1">
                  <c:v>500 BU/ml</c:v>
                </c:pt>
                <c:pt idx="2">
                  <c:v>1500 BU/ml</c:v>
                </c:pt>
                <c:pt idx="3">
                  <c:v>5000 BU/ml</c:v>
                </c:pt>
                <c:pt idx="4">
                  <c:v>10000 BU/ml</c:v>
                </c:pt>
                <c:pt idx="5">
                  <c:v>30000 BU/ml</c:v>
                </c:pt>
              </c:strCache>
            </c:strRef>
          </c:cat>
          <c:val>
            <c:numRef>
              <c:f>'PEFR stats'!$C$25:$C$30</c:f>
              <c:numCache>
                <c:formatCode>General</c:formatCode>
                <c:ptCount val="6"/>
                <c:pt idx="0">
                  <c:v>450.78947368421052</c:v>
                </c:pt>
                <c:pt idx="1">
                  <c:v>447.89473684210526</c:v>
                </c:pt>
                <c:pt idx="2">
                  <c:v>453.15789473684208</c:v>
                </c:pt>
                <c:pt idx="3">
                  <c:v>447.10526315789474</c:v>
                </c:pt>
                <c:pt idx="4">
                  <c:v>446.0526315789473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PEFR stats'!$G$1</c:f>
              <c:strCache>
                <c:ptCount val="1"/>
                <c:pt idx="0">
                  <c:v>active challenge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PEFR stats'!$H$25:$H$30</c:f>
                <c:numCache>
                  <c:formatCode>General</c:formatCode>
                  <c:ptCount val="6"/>
                  <c:pt idx="0">
                    <c:v>19.509608085072284</c:v>
                  </c:pt>
                  <c:pt idx="1">
                    <c:v>21.845980069182819</c:v>
                  </c:pt>
                  <c:pt idx="2">
                    <c:v>20.992237935840485</c:v>
                  </c:pt>
                  <c:pt idx="3">
                    <c:v>21.228613883134233</c:v>
                  </c:pt>
                  <c:pt idx="4">
                    <c:v>27.752513763657895</c:v>
                  </c:pt>
                  <c:pt idx="5">
                    <c:v>19.730324738475904</c:v>
                  </c:pt>
                </c:numCache>
              </c:numRef>
            </c:plus>
            <c:minus>
              <c:numRef>
                <c:f>'PEFR stats'!$H$25:$H$30</c:f>
                <c:numCache>
                  <c:formatCode>General</c:formatCode>
                  <c:ptCount val="6"/>
                  <c:pt idx="0">
                    <c:v>19.509608085072284</c:v>
                  </c:pt>
                  <c:pt idx="1">
                    <c:v>21.845980069182819</c:v>
                  </c:pt>
                  <c:pt idx="2">
                    <c:v>20.992237935840485</c:v>
                  </c:pt>
                  <c:pt idx="3">
                    <c:v>21.228613883134233</c:v>
                  </c:pt>
                  <c:pt idx="4">
                    <c:v>27.752513763657895</c:v>
                  </c:pt>
                  <c:pt idx="5">
                    <c:v>19.730324738475904</c:v>
                  </c:pt>
                </c:numCache>
              </c:numRef>
            </c:minus>
          </c:errBars>
          <c:cat>
            <c:strRef>
              <c:f>'PEFR stats'!$F$25:$F$30</c:f>
              <c:strCache>
                <c:ptCount val="6"/>
                <c:pt idx="0">
                  <c:v>post-lavage</c:v>
                </c:pt>
                <c:pt idx="1">
                  <c:v>500 BU/ml</c:v>
                </c:pt>
                <c:pt idx="2">
                  <c:v>1500 BU/ml</c:v>
                </c:pt>
                <c:pt idx="3">
                  <c:v>5000 BU/ml</c:v>
                </c:pt>
                <c:pt idx="4">
                  <c:v>10000 BU/ml</c:v>
                </c:pt>
                <c:pt idx="5">
                  <c:v>30000 BU/ml</c:v>
                </c:pt>
              </c:strCache>
            </c:strRef>
          </c:cat>
          <c:val>
            <c:numRef>
              <c:f>'PEFR stats'!$G$25:$G$30</c:f>
              <c:numCache>
                <c:formatCode>General</c:formatCode>
                <c:ptCount val="6"/>
                <c:pt idx="0">
                  <c:v>445.26315789473682</c:v>
                </c:pt>
                <c:pt idx="1">
                  <c:v>437.36842105263156</c:v>
                </c:pt>
                <c:pt idx="2">
                  <c:v>436.84210526315792</c:v>
                </c:pt>
                <c:pt idx="3">
                  <c:v>429.73684210526318</c:v>
                </c:pt>
                <c:pt idx="4">
                  <c:v>413.33333333333331</c:v>
                </c:pt>
                <c:pt idx="5">
                  <c:v>44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0959872"/>
        <c:axId val="90961408"/>
      </c:lineChart>
      <c:catAx>
        <c:axId val="90959872"/>
        <c:scaling>
          <c:orientation val="minMax"/>
        </c:scaling>
        <c:delete val="0"/>
        <c:axPos val="b"/>
        <c:majorTickMark val="out"/>
        <c:minorTickMark val="none"/>
        <c:tickLblPos val="nextTo"/>
        <c:crossAx val="90961408"/>
        <c:crosses val="autoZero"/>
        <c:auto val="1"/>
        <c:lblAlgn val="ctr"/>
        <c:lblOffset val="100"/>
        <c:noMultiLvlLbl val="0"/>
      </c:catAx>
      <c:valAx>
        <c:axId val="90961408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eak Expiratory Flow Rate (L/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0959872"/>
        <c:crosses val="autoZero"/>
        <c:crossBetween val="between"/>
      </c:valAx>
    </c:plotArea>
    <c:legend>
      <c:legendPos val="b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GB" sz="1400" b="0" dirty="0" smtClean="0"/>
              <a:t>Peak expiratory flow rate: time-course</a:t>
            </a:r>
            <a:endParaRPr lang="en-GB" sz="1400" b="0" dirty="0"/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0282785846531868"/>
          <c:y val="0.11043700812972658"/>
          <c:w val="0.87316777710478499"/>
          <c:h val="0.66685573391891295"/>
        </c:manualLayout>
      </c:layout>
      <c:lineChart>
        <c:grouping val="standard"/>
        <c:varyColors val="0"/>
        <c:ser>
          <c:idx val="0"/>
          <c:order val="0"/>
          <c:tx>
            <c:strRef>
              <c:f>'PEFR stats'!$C$1</c:f>
              <c:strCache>
                <c:ptCount val="1"/>
                <c:pt idx="0">
                  <c:v>diluent challenge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PEFR stats'!$D$3:$D$15</c:f>
                <c:numCache>
                  <c:formatCode>General</c:formatCode>
                  <c:ptCount val="13"/>
                  <c:pt idx="0">
                    <c:v>22.58955025793226</c:v>
                  </c:pt>
                  <c:pt idx="1">
                    <c:v>21.972414782816173</c:v>
                  </c:pt>
                  <c:pt idx="2">
                    <c:v>20.822203860107471</c:v>
                  </c:pt>
                  <c:pt idx="3">
                    <c:v>22.714386788771222</c:v>
                  </c:pt>
                  <c:pt idx="4">
                    <c:v>22.505257413880077</c:v>
                  </c:pt>
                  <c:pt idx="5">
                    <c:v>20.992421209337049</c:v>
                  </c:pt>
                  <c:pt idx="6">
                    <c:v>22.20147538762917</c:v>
                  </c:pt>
                  <c:pt idx="7">
                    <c:v>22.495853042824265</c:v>
                  </c:pt>
                  <c:pt idx="8">
                    <c:v>22.120921772281587</c:v>
                  </c:pt>
                  <c:pt idx="9">
                    <c:v>23.792636802597439</c:v>
                  </c:pt>
                  <c:pt idx="10">
                    <c:v>21.4580840019939</c:v>
                  </c:pt>
                  <c:pt idx="11">
                    <c:v>21.747133765710352</c:v>
                  </c:pt>
                  <c:pt idx="12">
                    <c:v>21.209938610115668</c:v>
                  </c:pt>
                </c:numCache>
              </c:numRef>
            </c:plus>
            <c:minus>
              <c:numRef>
                <c:f>'PEFR stats'!$D$3:$D$15</c:f>
                <c:numCache>
                  <c:formatCode>General</c:formatCode>
                  <c:ptCount val="13"/>
                  <c:pt idx="0">
                    <c:v>22.58955025793226</c:v>
                  </c:pt>
                  <c:pt idx="1">
                    <c:v>21.972414782816173</c:v>
                  </c:pt>
                  <c:pt idx="2">
                    <c:v>20.822203860107471</c:v>
                  </c:pt>
                  <c:pt idx="3">
                    <c:v>22.714386788771222</c:v>
                  </c:pt>
                  <c:pt idx="4">
                    <c:v>22.505257413880077</c:v>
                  </c:pt>
                  <c:pt idx="5">
                    <c:v>20.992421209337049</c:v>
                  </c:pt>
                  <c:pt idx="6">
                    <c:v>22.20147538762917</c:v>
                  </c:pt>
                  <c:pt idx="7">
                    <c:v>22.495853042824265</c:v>
                  </c:pt>
                  <c:pt idx="8">
                    <c:v>22.120921772281587</c:v>
                  </c:pt>
                  <c:pt idx="9">
                    <c:v>23.792636802597439</c:v>
                  </c:pt>
                  <c:pt idx="10">
                    <c:v>21.4580840019939</c:v>
                  </c:pt>
                  <c:pt idx="11">
                    <c:v>21.747133765710352</c:v>
                  </c:pt>
                  <c:pt idx="12">
                    <c:v>21.209938610115668</c:v>
                  </c:pt>
                </c:numCache>
              </c:numRef>
            </c:minus>
          </c:errBars>
          <c:cat>
            <c:strRef>
              <c:f>'PEFR stats'!$B$3:$B$15</c:f>
              <c:strCache>
                <c:ptCount val="13"/>
                <c:pt idx="0">
                  <c:v>baseline</c:v>
                </c:pt>
                <c:pt idx="1">
                  <c:v>post-lavage</c:v>
                </c:pt>
                <c:pt idx="2">
                  <c:v>5 min</c:v>
                </c:pt>
                <c:pt idx="3">
                  <c:v>15 min</c:v>
                </c:pt>
                <c:pt idx="4">
                  <c:v>30 min</c:v>
                </c:pt>
                <c:pt idx="5">
                  <c:v>1 hour</c:v>
                </c:pt>
                <c:pt idx="6">
                  <c:v>2 hour</c:v>
                </c:pt>
                <c:pt idx="7">
                  <c:v>3 hour</c:v>
                </c:pt>
                <c:pt idx="8">
                  <c:v>4 hour</c:v>
                </c:pt>
                <c:pt idx="9">
                  <c:v>5 hour</c:v>
                </c:pt>
                <c:pt idx="10">
                  <c:v>6 hour</c:v>
                </c:pt>
                <c:pt idx="11">
                  <c:v>7 hour</c:v>
                </c:pt>
                <c:pt idx="12">
                  <c:v>8 hour</c:v>
                </c:pt>
              </c:strCache>
            </c:strRef>
          </c:cat>
          <c:val>
            <c:numRef>
              <c:f>'PEFR stats'!$C$3:$C$15</c:f>
              <c:numCache>
                <c:formatCode>General</c:formatCode>
                <c:ptCount val="13"/>
                <c:pt idx="0">
                  <c:v>457.36842105263156</c:v>
                </c:pt>
                <c:pt idx="1">
                  <c:v>450.78947368421052</c:v>
                </c:pt>
                <c:pt idx="2">
                  <c:v>446.05263157894734</c:v>
                </c:pt>
                <c:pt idx="3">
                  <c:v>448.42105263157896</c:v>
                </c:pt>
                <c:pt idx="4">
                  <c:v>452.36842105263156</c:v>
                </c:pt>
                <c:pt idx="5">
                  <c:v>449.21052631578948</c:v>
                </c:pt>
                <c:pt idx="6">
                  <c:v>454.73684210526318</c:v>
                </c:pt>
                <c:pt idx="7">
                  <c:v>455.26315789473682</c:v>
                </c:pt>
                <c:pt idx="8">
                  <c:v>453.42105263157896</c:v>
                </c:pt>
                <c:pt idx="9">
                  <c:v>453.42105263157896</c:v>
                </c:pt>
                <c:pt idx="10">
                  <c:v>450.26315789473682</c:v>
                </c:pt>
                <c:pt idx="11">
                  <c:v>445.5263157894737</c:v>
                </c:pt>
                <c:pt idx="12">
                  <c:v>451.5789473684210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PEFR stats'!$G$1</c:f>
              <c:strCache>
                <c:ptCount val="1"/>
                <c:pt idx="0">
                  <c:v>active challenge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'PEFR stats'!$H$3:$H$15</c:f>
                <c:numCache>
                  <c:formatCode>General</c:formatCode>
                  <c:ptCount val="13"/>
                  <c:pt idx="0">
                    <c:v>21.126332980759141</c:v>
                  </c:pt>
                  <c:pt idx="1">
                    <c:v>19.509608085072284</c:v>
                  </c:pt>
                  <c:pt idx="2">
                    <c:v>18.921969656262387</c:v>
                  </c:pt>
                  <c:pt idx="3">
                    <c:v>19.29007003857042</c:v>
                  </c:pt>
                  <c:pt idx="4">
                    <c:v>19.82339695384676</c:v>
                  </c:pt>
                  <c:pt idx="5">
                    <c:v>21.231513422357683</c:v>
                  </c:pt>
                  <c:pt idx="6">
                    <c:v>22.128399198600953</c:v>
                  </c:pt>
                  <c:pt idx="7">
                    <c:v>21.187252333284921</c:v>
                  </c:pt>
                  <c:pt idx="8">
                    <c:v>20.746309472413305</c:v>
                  </c:pt>
                  <c:pt idx="9">
                    <c:v>22.768523520004745</c:v>
                  </c:pt>
                  <c:pt idx="10">
                    <c:v>23.179316248638266</c:v>
                  </c:pt>
                  <c:pt idx="11">
                    <c:v>23.387353376083968</c:v>
                  </c:pt>
                  <c:pt idx="12">
                    <c:v>22.1553317682623</c:v>
                  </c:pt>
                </c:numCache>
              </c:numRef>
            </c:plus>
            <c:minus>
              <c:numRef>
                <c:f>'PEFR stats'!$H$3:$H$15</c:f>
                <c:numCache>
                  <c:formatCode>General</c:formatCode>
                  <c:ptCount val="13"/>
                  <c:pt idx="0">
                    <c:v>21.126332980759141</c:v>
                  </c:pt>
                  <c:pt idx="1">
                    <c:v>19.509608085072284</c:v>
                  </c:pt>
                  <c:pt idx="2">
                    <c:v>18.921969656262387</c:v>
                  </c:pt>
                  <c:pt idx="3">
                    <c:v>19.29007003857042</c:v>
                  </c:pt>
                  <c:pt idx="4">
                    <c:v>19.82339695384676</c:v>
                  </c:pt>
                  <c:pt idx="5">
                    <c:v>21.231513422357683</c:v>
                  </c:pt>
                  <c:pt idx="6">
                    <c:v>22.128399198600953</c:v>
                  </c:pt>
                  <c:pt idx="7">
                    <c:v>21.187252333284921</c:v>
                  </c:pt>
                  <c:pt idx="8">
                    <c:v>20.746309472413305</c:v>
                  </c:pt>
                  <c:pt idx="9">
                    <c:v>22.768523520004745</c:v>
                  </c:pt>
                  <c:pt idx="10">
                    <c:v>23.179316248638266</c:v>
                  </c:pt>
                  <c:pt idx="11">
                    <c:v>23.387353376083968</c:v>
                  </c:pt>
                  <c:pt idx="12">
                    <c:v>22.1553317682623</c:v>
                  </c:pt>
                </c:numCache>
              </c:numRef>
            </c:minus>
          </c:errBars>
          <c:cat>
            <c:strRef>
              <c:f>'PEFR stats'!$B$3:$B$15</c:f>
              <c:strCache>
                <c:ptCount val="13"/>
                <c:pt idx="0">
                  <c:v>baseline</c:v>
                </c:pt>
                <c:pt idx="1">
                  <c:v>post-lavage</c:v>
                </c:pt>
                <c:pt idx="2">
                  <c:v>5 min</c:v>
                </c:pt>
                <c:pt idx="3">
                  <c:v>15 min</c:v>
                </c:pt>
                <c:pt idx="4">
                  <c:v>30 min</c:v>
                </c:pt>
                <c:pt idx="5">
                  <c:v>1 hour</c:v>
                </c:pt>
                <c:pt idx="6">
                  <c:v>2 hour</c:v>
                </c:pt>
                <c:pt idx="7">
                  <c:v>3 hour</c:v>
                </c:pt>
                <c:pt idx="8">
                  <c:v>4 hour</c:v>
                </c:pt>
                <c:pt idx="9">
                  <c:v>5 hour</c:v>
                </c:pt>
                <c:pt idx="10">
                  <c:v>6 hour</c:v>
                </c:pt>
                <c:pt idx="11">
                  <c:v>7 hour</c:v>
                </c:pt>
                <c:pt idx="12">
                  <c:v>8 hour</c:v>
                </c:pt>
              </c:strCache>
            </c:strRef>
          </c:cat>
          <c:val>
            <c:numRef>
              <c:f>'PEFR stats'!$G$3:$G$15</c:f>
              <c:numCache>
                <c:formatCode>General</c:formatCode>
                <c:ptCount val="13"/>
                <c:pt idx="0">
                  <c:v>448.68421052631578</c:v>
                </c:pt>
                <c:pt idx="1">
                  <c:v>445.26315789473682</c:v>
                </c:pt>
                <c:pt idx="2">
                  <c:v>425</c:v>
                </c:pt>
                <c:pt idx="3">
                  <c:v>423.15789473684208</c:v>
                </c:pt>
                <c:pt idx="4">
                  <c:v>430.5263157894737</c:v>
                </c:pt>
                <c:pt idx="5">
                  <c:v>432.89473684210526</c:v>
                </c:pt>
                <c:pt idx="6">
                  <c:v>437.10526315789474</c:v>
                </c:pt>
                <c:pt idx="7">
                  <c:v>439.73684210526318</c:v>
                </c:pt>
                <c:pt idx="8">
                  <c:v>440</c:v>
                </c:pt>
                <c:pt idx="9">
                  <c:v>440.5263157894737</c:v>
                </c:pt>
                <c:pt idx="10">
                  <c:v>445</c:v>
                </c:pt>
                <c:pt idx="11">
                  <c:v>444.21052631578948</c:v>
                </c:pt>
                <c:pt idx="12">
                  <c:v>445.2631578947368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2499968"/>
        <c:axId val="162501760"/>
      </c:lineChart>
      <c:catAx>
        <c:axId val="162499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62501760"/>
        <c:crosses val="autoZero"/>
        <c:auto val="1"/>
        <c:lblAlgn val="ctr"/>
        <c:lblOffset val="100"/>
        <c:noMultiLvlLbl val="0"/>
      </c:catAx>
      <c:valAx>
        <c:axId val="162501760"/>
        <c:scaling>
          <c:orientation val="minMax"/>
          <c:max val="500"/>
          <c:min val="0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  <a:effectLst>
              <a:outerShdw blurRad="50800" dist="50800" dir="5400000" algn="ctr" rotWithShape="0">
                <a:schemeClr val="bg1"/>
              </a:outerShdw>
            </a:effectLst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Peak Expiratory Flow Rate (L/mi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2499968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6407</cdr:x>
      <cdr:y>0.11478</cdr:y>
    </cdr:to>
    <cdr:sp macro="" textlink="">
      <cdr:nvSpPr>
        <cdr:cNvPr id="2" name="TextBox 5"/>
        <cdr:cNvSpPr txBox="1"/>
      </cdr:nvSpPr>
      <cdr:spPr>
        <a:xfrm xmlns:a="http://schemas.openxmlformats.org/drawingml/2006/main">
          <a:off x="0" y="0"/>
          <a:ext cx="328141" cy="38586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dirty="0" smtClean="0"/>
            <a:t>B</a:t>
          </a:r>
          <a:endParaRPr lang="en-GB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EF0575-452D-46B5-9E55-922C938D134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D31B49-66CC-4C8C-AFE8-2BAF7EF1DD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59936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mtClean="0"/>
              <a:t>Figure </a:t>
            </a:r>
            <a:r>
              <a:rPr lang="en-GB" smtClean="0"/>
              <a:t>S2: </a:t>
            </a:r>
            <a:r>
              <a:rPr lang="en-GB" dirty="0" smtClean="0"/>
              <a:t>Peak</a:t>
            </a:r>
            <a:r>
              <a:rPr lang="en-GB" baseline="0" dirty="0" smtClean="0"/>
              <a:t> expiratory flow rate</a:t>
            </a:r>
            <a:r>
              <a:rPr lang="en-GB" dirty="0" smtClean="0"/>
              <a:t> (PNIF) response to active and diluent nasal challenge, mean</a:t>
            </a:r>
            <a:r>
              <a:rPr lang="en-GB" baseline="0" dirty="0" smtClean="0"/>
              <a:t> and standard error</a:t>
            </a:r>
            <a:r>
              <a:rPr lang="en-GB" dirty="0" smtClean="0"/>
              <a:t>. A, dose-response; B, time-course response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D31B49-66CC-4C8C-AFE8-2BAF7EF1DDB7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79311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2529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6978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4294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731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6730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18613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7671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1020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7083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7985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5132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B6F86-A6A3-4E72-AEA3-3F09754F3983}" type="datetimeFigureOut">
              <a:rPr lang="en-GB" smtClean="0"/>
              <a:t>23/06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FCB5D0-ACDF-4C4A-B336-B0C696641D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383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97944397"/>
              </p:ext>
            </p:extLst>
          </p:nvPr>
        </p:nvGraphicFramePr>
        <p:xfrm>
          <a:off x="107504" y="260648"/>
          <a:ext cx="4968552" cy="3168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2008" y="0"/>
            <a:ext cx="32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5552246"/>
              </p:ext>
            </p:extLst>
          </p:nvPr>
        </p:nvGraphicFramePr>
        <p:xfrm>
          <a:off x="72008" y="3501008"/>
          <a:ext cx="5049957" cy="3217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4221534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61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scad</dc:creator>
  <cp:lastModifiedBy>gscad</cp:lastModifiedBy>
  <cp:revision>3</cp:revision>
  <dcterms:created xsi:type="dcterms:W3CDTF">2014-04-25T11:08:36Z</dcterms:created>
  <dcterms:modified xsi:type="dcterms:W3CDTF">2014-06-23T18:17:54Z</dcterms:modified>
</cp:coreProperties>
</file>